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3" d="100"/>
          <a:sy n="93" d="100"/>
        </p:scale>
        <p:origin x="33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415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31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905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557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798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90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130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220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7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649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541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A122D-A30A-4149-9FE9-4AC019CE7394}" type="datetimeFigureOut">
              <a:rPr lang="en-US" smtClean="0"/>
              <a:t>9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91AED-3A03-2B47-B737-6C590BA4E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205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BA595F5E-0684-B2A4-DFC6-40424D7B5C3D}"/>
              </a:ext>
            </a:extLst>
          </p:cNvPr>
          <p:cNvSpPr txBox="1"/>
          <p:nvPr/>
        </p:nvSpPr>
        <p:spPr>
          <a:xfrm>
            <a:off x="333189" y="7612644"/>
            <a:ext cx="6254262" cy="147732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orship curves for honey bee workers that were stressed during pupation with either A) cold stress (2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for 24 h), B) heat stress (39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for 24 h), or C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ro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te parasitization. Statistical evaluation was done with a Kaplan Meier survivorship curve and a log rank test. Stressed bees (orange survivorship curves) died significantly faster than bees in their respective control groups (blue survivorship curves) when they were exposed to cold stres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), as well as to heat stress (p &lt; 0.0001). There was a similar trend when bees were parasitized by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ro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tes, but not significantly so (p = 0.062). Asterisks (“***”) next to the brackets represent statistically significant differences between treatment groups (a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). </a:t>
            </a:r>
            <a:endParaRPr lang="en-US" sz="12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EBC7D72C-6D87-458B-EB01-FF797F96E358}"/>
              </a:ext>
            </a:extLst>
          </p:cNvPr>
          <p:cNvGrpSpPr/>
          <p:nvPr/>
        </p:nvGrpSpPr>
        <p:grpSpPr>
          <a:xfrm>
            <a:off x="1694547" y="5088354"/>
            <a:ext cx="3404698" cy="2546066"/>
            <a:chOff x="2211472" y="6917822"/>
            <a:chExt cx="4684008" cy="3749040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4AB25753-D368-E42F-B326-EC7DF129ED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1472" y="6917822"/>
              <a:ext cx="4684008" cy="3749040"/>
            </a:xfrm>
            <a:prstGeom prst="rect">
              <a:avLst/>
            </a:prstGeom>
          </p:spPr>
        </p:pic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D022CFE-240C-D515-7619-FA330DBC3CDE}"/>
                </a:ext>
              </a:extLst>
            </p:cNvPr>
            <p:cNvGrpSpPr/>
            <p:nvPr/>
          </p:nvGrpSpPr>
          <p:grpSpPr>
            <a:xfrm>
              <a:off x="3184547" y="9094314"/>
              <a:ext cx="1165802" cy="788321"/>
              <a:chOff x="1635339" y="1027481"/>
              <a:chExt cx="1165802" cy="697990"/>
            </a:xfrm>
            <a:solidFill>
              <a:schemeClr val="bg1"/>
            </a:solidFill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D8FD0B5E-C63E-B5E7-A7D7-C27DDA82D01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/>
              <a:srcRect l="31395" t="5606" r="65376" b="91528"/>
              <a:stretch/>
            </p:blipFill>
            <p:spPr>
              <a:xfrm>
                <a:off x="1635339" y="1129109"/>
                <a:ext cx="232983" cy="177744"/>
              </a:xfrm>
              <a:prstGeom prst="rect">
                <a:avLst/>
              </a:prstGeom>
              <a:grpFill/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BCD3D199-DAA0-4CF0-8CAD-C9EDB7407E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7695" t="5650" r="29421" b="91790"/>
              <a:stretch/>
            </p:blipFill>
            <p:spPr>
              <a:xfrm>
                <a:off x="1635339" y="1433813"/>
                <a:ext cx="232983" cy="177744"/>
              </a:xfrm>
              <a:prstGeom prst="rect">
                <a:avLst/>
              </a:prstGeom>
              <a:grpFill/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C115D5D-B76E-49F9-0E2F-3F01434DCBB8}"/>
                  </a:ext>
                </a:extLst>
              </p:cNvPr>
              <p:cNvSpPr txBox="1"/>
              <p:nvPr/>
            </p:nvSpPr>
            <p:spPr>
              <a:xfrm>
                <a:off x="1865218" y="1027481"/>
                <a:ext cx="659270" cy="383976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ite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0A60ABE4-9DEB-66FD-622D-43908436C8A3}"/>
                  </a:ext>
                </a:extLst>
              </p:cNvPr>
              <p:cNvSpPr txBox="1"/>
              <p:nvPr/>
            </p:nvSpPr>
            <p:spPr>
              <a:xfrm>
                <a:off x="1865218" y="1341496"/>
                <a:ext cx="935923" cy="383975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2CAF0DF-8E0A-338E-4043-834D7278DDAE}"/>
                </a:ext>
              </a:extLst>
            </p:cNvPr>
            <p:cNvSpPr txBox="1"/>
            <p:nvPr/>
          </p:nvSpPr>
          <p:spPr>
            <a:xfrm>
              <a:off x="6131008" y="7086157"/>
              <a:ext cx="488125" cy="433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45637D3-6ECD-8939-467B-FC4C9CCE2306}"/>
              </a:ext>
            </a:extLst>
          </p:cNvPr>
          <p:cNvGrpSpPr/>
          <p:nvPr/>
        </p:nvGrpSpPr>
        <p:grpSpPr>
          <a:xfrm>
            <a:off x="1694547" y="2669421"/>
            <a:ext cx="3744955" cy="2458480"/>
            <a:chOff x="2210269" y="3486052"/>
            <a:chExt cx="5067650" cy="3468747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0983608-7B50-FAAF-FADA-529043AE99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7476"/>
            <a:stretch/>
          </p:blipFill>
          <p:spPr>
            <a:xfrm>
              <a:off x="2210269" y="3486052"/>
              <a:ext cx="4684009" cy="3468747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5B99CE6B-B760-35F9-36BF-550BB51DC8BE}"/>
                </a:ext>
              </a:extLst>
            </p:cNvPr>
            <p:cNvGrpSpPr/>
            <p:nvPr/>
          </p:nvGrpSpPr>
          <p:grpSpPr>
            <a:xfrm>
              <a:off x="3180063" y="5701667"/>
              <a:ext cx="1152404" cy="745510"/>
              <a:chOff x="1635339" y="984551"/>
              <a:chExt cx="1152404" cy="745510"/>
            </a:xfrm>
            <a:solidFill>
              <a:schemeClr val="bg1"/>
            </a:solidFill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1288FA13-2205-AB63-FF6E-337B24993B0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/>
              <a:srcRect l="31395" t="5606" r="65376" b="91528"/>
              <a:stretch/>
            </p:blipFill>
            <p:spPr>
              <a:xfrm>
                <a:off x="1635339" y="1129109"/>
                <a:ext cx="232983" cy="177744"/>
              </a:xfrm>
              <a:prstGeom prst="rect">
                <a:avLst/>
              </a:prstGeom>
              <a:grpFill/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E916B909-15AB-A7D4-A045-4701FFB9DC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7695" t="5650" r="29421" b="91790"/>
              <a:stretch/>
            </p:blipFill>
            <p:spPr>
              <a:xfrm>
                <a:off x="1635339" y="1433813"/>
                <a:ext cx="232983" cy="177744"/>
              </a:xfrm>
              <a:prstGeom prst="rect">
                <a:avLst/>
              </a:prstGeom>
              <a:grpFill/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9E5BBDF-7678-3E93-D188-30E1A2A6384D}"/>
                  </a:ext>
                </a:extLst>
              </p:cNvPr>
              <p:cNvSpPr txBox="1"/>
              <p:nvPr/>
            </p:nvSpPr>
            <p:spPr>
              <a:xfrm>
                <a:off x="1842121" y="984551"/>
                <a:ext cx="597410" cy="431491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Hot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755FB79-ECF2-DC13-8410-F65E9E652FAE}"/>
                  </a:ext>
                </a:extLst>
              </p:cNvPr>
              <p:cNvSpPr txBox="1"/>
              <p:nvPr/>
            </p:nvSpPr>
            <p:spPr>
              <a:xfrm>
                <a:off x="1842121" y="1298569"/>
                <a:ext cx="945622" cy="431492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C972336-FE4F-4DD1-101C-5DD3F495E679}"/>
                </a:ext>
              </a:extLst>
            </p:cNvPr>
            <p:cNvSpPr txBox="1"/>
            <p:nvPr/>
          </p:nvSpPr>
          <p:spPr>
            <a:xfrm>
              <a:off x="6164130" y="3530149"/>
              <a:ext cx="440776" cy="369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49" name="Right Brace 48">
              <a:extLst>
                <a:ext uri="{FF2B5EF4-FFF2-40B4-BE49-F238E27FC236}">
                  <a16:creationId xmlns:a16="http://schemas.microsoft.com/office/drawing/2014/main" id="{D0F42C43-9103-5F63-FE18-603A60139D9A}"/>
                </a:ext>
              </a:extLst>
            </p:cNvPr>
            <p:cNvSpPr/>
            <p:nvPr/>
          </p:nvSpPr>
          <p:spPr>
            <a:xfrm>
              <a:off x="6703451" y="4374543"/>
              <a:ext cx="168624" cy="1371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00E511E-A408-6006-57AC-487D287AB302}"/>
                </a:ext>
              </a:extLst>
            </p:cNvPr>
            <p:cNvSpPr txBox="1"/>
            <p:nvPr/>
          </p:nvSpPr>
          <p:spPr>
            <a:xfrm>
              <a:off x="6823949" y="4940346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**</a:t>
              </a:r>
              <a:endParaRPr lang="en-US" sz="1600" dirty="0"/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1F6AC6F2-FEDA-6EED-159A-F1837482FDC8}"/>
              </a:ext>
            </a:extLst>
          </p:cNvPr>
          <p:cNvGrpSpPr/>
          <p:nvPr/>
        </p:nvGrpSpPr>
        <p:grpSpPr>
          <a:xfrm>
            <a:off x="1709821" y="69658"/>
            <a:ext cx="3714051" cy="2629500"/>
            <a:chOff x="2188067" y="105763"/>
            <a:chExt cx="5019240" cy="3338881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82376B0A-352D-749C-2CFB-5300E5E6AA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624" b="8315"/>
            <a:stretch/>
          </p:blipFill>
          <p:spPr>
            <a:xfrm>
              <a:off x="2188067" y="105763"/>
              <a:ext cx="4684008" cy="3338881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34AB619-E0AE-4E24-C359-9E258339FA06}"/>
                </a:ext>
              </a:extLst>
            </p:cNvPr>
            <p:cNvSpPr txBox="1"/>
            <p:nvPr/>
          </p:nvSpPr>
          <p:spPr>
            <a:xfrm>
              <a:off x="6243508" y="133407"/>
              <a:ext cx="516157" cy="4256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05BD5D4B-3449-A1D3-9258-41F3C3E848D7}"/>
                </a:ext>
              </a:extLst>
            </p:cNvPr>
            <p:cNvGrpSpPr/>
            <p:nvPr/>
          </p:nvGrpSpPr>
          <p:grpSpPr>
            <a:xfrm>
              <a:off x="3180063" y="2291900"/>
              <a:ext cx="1149284" cy="716045"/>
              <a:chOff x="1635339" y="1016563"/>
              <a:chExt cx="1149284" cy="716045"/>
            </a:xfrm>
            <a:solidFill>
              <a:schemeClr val="bg1"/>
            </a:solidFill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4556DFD6-086A-5C12-A82F-9E3EDBCC90B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/>
              <a:srcRect l="31395" t="5606" r="65376" b="91528"/>
              <a:stretch/>
            </p:blipFill>
            <p:spPr>
              <a:xfrm>
                <a:off x="1635339" y="1129109"/>
                <a:ext cx="232983" cy="177744"/>
              </a:xfrm>
              <a:prstGeom prst="rect">
                <a:avLst/>
              </a:prstGeom>
              <a:grpFill/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B358EF9E-2234-F5B4-5ECB-FF4FDBD994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7695" t="5650" r="29421" b="91790"/>
              <a:stretch/>
            </p:blipFill>
            <p:spPr>
              <a:xfrm>
                <a:off x="1635339" y="1433813"/>
                <a:ext cx="232983" cy="177744"/>
              </a:xfrm>
              <a:prstGeom prst="rect">
                <a:avLst/>
              </a:prstGeom>
              <a:grpFill/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B0C923D-E929-16DA-B03E-6BDF18CB74C2}"/>
                  </a:ext>
                </a:extLst>
              </p:cNvPr>
              <p:cNvSpPr txBox="1"/>
              <p:nvPr/>
            </p:nvSpPr>
            <p:spPr>
              <a:xfrm>
                <a:off x="1809007" y="1016563"/>
                <a:ext cx="726336" cy="402029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ld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EC8B0F0-D21F-04FA-4A36-EDA02AEF7804}"/>
                  </a:ext>
                </a:extLst>
              </p:cNvPr>
              <p:cNvSpPr txBox="1"/>
              <p:nvPr/>
            </p:nvSpPr>
            <p:spPr>
              <a:xfrm>
                <a:off x="1809007" y="1330579"/>
                <a:ext cx="975616" cy="402029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sp>
          <p:nvSpPr>
            <p:cNvPr id="48" name="Right Brace 47">
              <a:extLst>
                <a:ext uri="{FF2B5EF4-FFF2-40B4-BE49-F238E27FC236}">
                  <a16:creationId xmlns:a16="http://schemas.microsoft.com/office/drawing/2014/main" id="{088DB781-21E2-9F05-B9B1-15851E880550}"/>
                </a:ext>
              </a:extLst>
            </p:cNvPr>
            <p:cNvSpPr/>
            <p:nvPr/>
          </p:nvSpPr>
          <p:spPr>
            <a:xfrm>
              <a:off x="6655325" y="1057107"/>
              <a:ext cx="168623" cy="354617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BFC4248-6174-2DBE-9DCA-FAB3819A0AD2}"/>
                </a:ext>
              </a:extLst>
            </p:cNvPr>
            <p:cNvSpPr txBox="1"/>
            <p:nvPr/>
          </p:nvSpPr>
          <p:spPr>
            <a:xfrm>
              <a:off x="6753337" y="1121151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**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444174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34</TotalTime>
  <Words>160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User</cp:lastModifiedBy>
  <cp:revision>11</cp:revision>
  <dcterms:created xsi:type="dcterms:W3CDTF">2023-04-28T19:10:32Z</dcterms:created>
  <dcterms:modified xsi:type="dcterms:W3CDTF">2024-09-06T03:13:38Z</dcterms:modified>
</cp:coreProperties>
</file>